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4F16F9-8AA4-4F24-BF49-83677DE66568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an proximate composition (g/100g) ± SD of cachapinta pulp  and cachapinta pâté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Espaço Reservado para Número de Slid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663834-AF1F-44B2-8BD3-C8F25821DF6E}" type="slidenum">
              <a:rPr b="0" lang="pt-B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77783-99AD-415E-BC2B-0CE1ED3BD0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C19266-C4BF-4319-AB0A-D828FB9631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936B5-DA8B-4690-AC34-0E49AC9DD1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72832-6C28-4531-AE97-2ED91D0E47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F1CC7-F68C-4A85-A1B2-3031E2E26E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C4B95-5B74-4CB7-A554-633F9C2F46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0CA06-CDFC-4507-A9DE-C2A486D77C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FBCE1-2A7D-4562-9A4A-01FCBB301A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9ACE63-C1B2-438D-B50E-220DE49067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5230D-7D92-4270-9636-D86C5B7AA3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81CB0-EECB-422F-855D-08776A270A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86189-C8B4-487D-948D-78F5A6C5A6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4C0AE1-93B8-411B-B74D-D1AFA94DFCD7}" type="slidenum">
              <a:rPr b="0" lang="pt-B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24000" y="260280"/>
            <a:ext cx="8496000" cy="1008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600"/>
            </a:b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evelopment and nutritional and sensory evaluation of cachapinta (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seudoplatystoma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p) pâté</a:t>
            </a:r>
            <a:br>
              <a:rPr sz="4000"/>
            </a:b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1187280" y="1989000"/>
          <a:ext cx="6985080" cy="2303640"/>
        </p:xfrm>
        <a:graphic>
          <a:graphicData uri="http://schemas.openxmlformats.org/drawingml/2006/table">
            <a:tbl>
              <a:tblPr/>
              <a:tblGrid>
                <a:gridCol w="1478160"/>
                <a:gridCol w="1409760"/>
                <a:gridCol w="1279440"/>
                <a:gridCol w="1407960"/>
                <a:gridCol w="1409760"/>
              </a:tblGrid>
              <a:tr h="7686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Sample n=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Moistur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Ash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Prote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Lipid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6680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Pul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75.49± 1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1.00±0.1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15.00±0.2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7.92±1.3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682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Pâté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63.14±0.7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2.09±0.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8.34±0.3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SimSun"/>
                        </a:rPr>
                        <a:t>24.46±0.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18T16:33:40Z</dcterms:created>
  <dc:creator>Seven</dc:creator>
  <dc:description/>
  <dc:language>en-US</dc:language>
  <cp:lastModifiedBy>Seven</cp:lastModifiedBy>
  <dcterms:modified xsi:type="dcterms:W3CDTF">2014-10-18T18:41:07Z</dcterms:modified>
  <cp:revision>7</cp:revision>
  <dc:subject/>
  <dc:title>Apresentação do PowerPoint</dc:title>
</cp:coreProperties>
</file>